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686" r:id="rId2"/>
    <p:sldId id="683" r:id="rId3"/>
    <p:sldId id="692" r:id="rId4"/>
    <p:sldId id="681" r:id="rId5"/>
    <p:sldId id="693" r:id="rId6"/>
    <p:sldId id="668" r:id="rId7"/>
    <p:sldId id="691" r:id="rId8"/>
  </p:sldIdLst>
  <p:sldSz cx="12192000" cy="6858000"/>
  <p:notesSz cx="7023100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917" autoAdjust="0"/>
    <p:restoredTop sz="93885" autoAdjust="0"/>
  </p:normalViewPr>
  <p:slideViewPr>
    <p:cSldViewPr snapToGrid="0">
      <p:cViewPr>
        <p:scale>
          <a:sx n="87" d="100"/>
          <a:sy n="87" d="100"/>
        </p:scale>
        <p:origin x="60" y="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3238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8275" y="0"/>
            <a:ext cx="3043238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AEC0435-0BC9-4449-86EF-3184DF097B13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9138" y="1163638"/>
            <a:ext cx="5584825" cy="31416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9925"/>
            <a:ext cx="5619750" cy="36655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375"/>
            <a:ext cx="3043238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8275" y="8842375"/>
            <a:ext cx="3043238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5BD525-641D-4A0A-B461-707E5EF0B4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98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C5BD525-641D-4A0A-B461-707E5EF0B46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00666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0E35C3-210A-4A8B-BD2B-0A17296C573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316D63C-BB4B-4DC5-A86E-46B23232C95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BF86C1-683B-45DB-9DD0-0DD535B96F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16E5C-8763-4A15-950E-0EAF0F42A965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E422A3-96F5-4791-9266-131DC19542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A2A32D-C79F-484E-9F87-91A7DDFBB1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D09B4-0F35-4AF6-91CA-5238C3EC4F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04679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065AAE-E1DD-4E14-A2BE-485BF6944C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FABAAB-DEB1-43FD-A9BC-2F818FC1AB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3A24DB-341B-48C4-8423-8449137A6D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16E5C-8763-4A15-950E-0EAF0F42A965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64FF00-99BB-4D16-B500-7D671E6BC1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20B9F6-D9B4-459C-838C-4CFC646EC9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D09B4-0F35-4AF6-91CA-5238C3EC4F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0421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54F754D-89FE-4BA0-BA73-3193A44CEE1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786AF7-C540-42D2-B6D8-D5EB91ADCD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BBDF81-50A5-4EB5-A396-83DF0DF971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16E5C-8763-4A15-950E-0EAF0F42A965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D35DAB-C92C-4F89-A9A0-E409BF88C8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DDF2F5-4CC3-4878-B902-29780C102E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D09B4-0F35-4AF6-91CA-5238C3EC4F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4412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5FA336-C908-482D-8550-B5F8BA91D8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8765EE-3161-419A-B3C3-AB4F688D1E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2FBBCF-4B92-4335-AA73-D5924856C6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16E5C-8763-4A15-950E-0EAF0F42A965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3A47DB-0F03-45FA-B1C4-F5ED89F356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49C7FF-DFBD-4BCD-A33C-414583182B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D09B4-0F35-4AF6-91CA-5238C3EC4F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3158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D87B0E-2BC7-4BF0-8B71-4A51887264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6D080C-ACC8-4426-A4A9-40542FE48A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2B057D-EA95-44AD-B3DB-05FED958DF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16E5C-8763-4A15-950E-0EAF0F42A965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8DB5F4-4AA3-4288-A565-1912E6B0FD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725C2B-A6DA-49E6-92AF-5629E72A7E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D09B4-0F35-4AF6-91CA-5238C3EC4F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1091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3A04D6-8260-4794-8C19-860502866E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AF9680-2087-46D9-8B83-A105C8A5E9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3BF5D3C-A683-4546-9CCA-6B4A3225D5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830B50-F027-4247-B2E3-59EAE1069F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16E5C-8763-4A15-950E-0EAF0F42A965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FE43BA-AA49-4D69-89F0-C55EB514C4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F5B190-7455-4780-B7DE-7456137C9A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D09B4-0F35-4AF6-91CA-5238C3EC4F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28337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F408F3-C077-47E7-A89E-96F3AD0CBD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C4B3F1-53C1-4B17-B38E-2EC7CE752B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814FD3C-8312-4F1E-8EBC-DB8198CB00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6CCEED8-A531-4F53-8E7B-C48EA57E792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51C4CCA-8DF2-4EBC-8A2A-6EA752E947A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29549F4-6D22-4A03-B0F5-ED30D2375C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16E5C-8763-4A15-950E-0EAF0F42A965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21C9F58-E093-428A-8FCA-8D4A8949B6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760A3DD-0E6D-44E7-AA5D-89C9F47581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D09B4-0F35-4AF6-91CA-5238C3EC4F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6281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9F84C8-5B25-468C-AEC3-6B642B388B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1B36B35-1CCF-4A1D-8205-A9E21BD95F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16E5C-8763-4A15-950E-0EAF0F42A965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3ECB558-5F6B-4543-9EF4-92882E40AD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273A184-286E-41DF-BBC1-6DE5BF935E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D09B4-0F35-4AF6-91CA-5238C3EC4F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7698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CE6E782-8A7C-4F91-9BD3-D3F9475F87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16E5C-8763-4A15-950E-0EAF0F42A965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CE779F1-05EC-4758-AE75-21E1266A28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AA559AE-09C8-46F0-828C-0606BCB363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D09B4-0F35-4AF6-91CA-5238C3EC4F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0247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C686BB-BC59-4CC2-BC65-AFAE582664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C14CC8-83C6-486E-A29C-5DC06581644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080605-A01A-4417-ACB5-0FE9CF363B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2A70E1-6D06-47DF-8182-A47B6978DC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16E5C-8763-4A15-950E-0EAF0F42A965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7C3C84-C2C6-4BF9-88B2-286560C384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BFD9EB-5270-4C42-BC7A-3B0DF80727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D09B4-0F35-4AF6-91CA-5238C3EC4F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7181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D32BC5-FC12-40FD-8C40-6A45EBC295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596DF61-9A76-420D-9AFA-976AD219765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AD99795-B42A-431F-AF1C-635F82DC6E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B227F5-9E8E-46E4-A6DA-9717D5EE50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16E5C-8763-4A15-950E-0EAF0F42A965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B6E5B3-91DD-4BA4-A274-403BB9193B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3B198A4-2DD9-4533-B05F-41DBB2B587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D09B4-0F35-4AF6-91CA-5238C3EC4F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1202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75F4906-CC7F-4080-9924-AAA22C8941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AB5980B-B62C-4058-A3E9-ED65A1A88E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32154A-C72E-4D35-9A36-D956128664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416E5C-8763-4A15-950E-0EAF0F42A965}" type="datetimeFigureOut">
              <a:rPr lang="en-US" smtClean="0"/>
              <a:t>11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46A02E-06ED-402D-98E9-34C7CAD124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BD7666-3C28-40F2-A09B-F6D0A3616A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DD09B4-0F35-4AF6-91CA-5238C3EC4F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8434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erson standing next to a cow&#10;&#10;Description automatically generated">
            <a:extLst>
              <a:ext uri="{FF2B5EF4-FFF2-40B4-BE49-F238E27FC236}">
                <a16:creationId xmlns:a16="http://schemas.microsoft.com/office/drawing/2014/main" id="{CE1886FA-3BFB-4389-9940-CFD5F244D90C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7360" y="1865792"/>
            <a:ext cx="1808753" cy="2411670"/>
          </a:xfrm>
          <a:prstGeom prst="rect">
            <a:avLst/>
          </a:prstGeom>
        </p:spPr>
      </p:pic>
      <p:pic>
        <p:nvPicPr>
          <p:cNvPr id="5" name="Picture 4" descr="A person petting a sheep&#10;&#10;Description automatically generated">
            <a:extLst>
              <a:ext uri="{FF2B5EF4-FFF2-40B4-BE49-F238E27FC236}">
                <a16:creationId xmlns:a16="http://schemas.microsoft.com/office/drawing/2014/main" id="{EFBF9F71-8F71-4565-82B3-DB7A8F9584A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07" t="63101" r="41637" b="3516"/>
          <a:stretch/>
        </p:blipFill>
        <p:spPr>
          <a:xfrm>
            <a:off x="2003249" y="1865127"/>
            <a:ext cx="2540000" cy="2413000"/>
          </a:xfrm>
          <a:prstGeom prst="rect">
            <a:avLst/>
          </a:prstGeom>
        </p:spPr>
      </p:pic>
      <p:pic>
        <p:nvPicPr>
          <p:cNvPr id="6" name="Content Placeholder 4" descr="A person petting a sheep&#10;&#10;Description automatically generated">
            <a:extLst>
              <a:ext uri="{FF2B5EF4-FFF2-40B4-BE49-F238E27FC236}">
                <a16:creationId xmlns:a16="http://schemas.microsoft.com/office/drawing/2014/main" id="{4F86C4E9-99AD-4984-A775-8D1D0F06FD2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13" t="54307" r="49243" b="22246"/>
          <a:stretch/>
        </p:blipFill>
        <p:spPr>
          <a:xfrm>
            <a:off x="7380224" y="1865128"/>
            <a:ext cx="2448555" cy="2412999"/>
          </a:xfr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CE02D49-A7B2-48E9-AD53-9BEB936CD3B7}"/>
              </a:ext>
            </a:extLst>
          </p:cNvPr>
          <p:cNvSpPr txBox="1"/>
          <p:nvPr/>
        </p:nvSpPr>
        <p:spPr>
          <a:xfrm>
            <a:off x="529021" y="4633354"/>
            <a:ext cx="1136578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ets of three goats were vaccinated with either RVFV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DDVax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or MP-12. At 1, 2, and 3 dpi, mosquitoes were allowed to feed on the goats, then assayed for the presence of virus 7 days later.</a:t>
            </a:r>
          </a:p>
          <a:p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65772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CFA80F58-E7CB-43C9-A051-759F340DF4DB}"/>
              </a:ext>
            </a:extLst>
          </p:cNvPr>
          <p:cNvSpPr txBox="1"/>
          <p:nvPr/>
        </p:nvSpPr>
        <p:spPr>
          <a:xfrm>
            <a:off x="305889" y="4716719"/>
            <a:ext cx="1140100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VFV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DDVax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dose response experiment was performed to test the hypothesis that </a:t>
            </a:r>
            <a:r>
              <a:rPr lang="en-US" i="1" dirty="0" err="1">
                <a:latin typeface="Arial" panose="020B0604020202020204" pitchFamily="34" charset="0"/>
                <a:cs typeface="Arial" panose="020B0604020202020204" pitchFamily="34" charset="0"/>
              </a:rPr>
              <a:t>Cx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i="1" dirty="0" err="1">
                <a:latin typeface="Arial" panose="020B0604020202020204" pitchFamily="34" charset="0"/>
                <a:cs typeface="Arial" panose="020B0604020202020204" pitchFamily="34" charset="0"/>
              </a:rPr>
              <a:t>tarsalis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nfection rates with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DDVax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vary as a function of blood meal titer. Data are a compilation of 3 biological replicates (n=30 per replicate).</a:t>
            </a:r>
          </a:p>
          <a:p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40917717"/>
              </p:ext>
            </p:extLst>
          </p:nvPr>
        </p:nvGraphicFramePr>
        <p:xfrm>
          <a:off x="396875" y="993775"/>
          <a:ext cx="10888663" cy="39893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8856097" imgH="3244628" progId="Prism8.Document">
                  <p:embed/>
                </p:oleObj>
              </mc:Choice>
              <mc:Fallback>
                <p:oleObj name="Prism 8" r:id="rId3" imgW="8856097" imgH="324462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96875" y="993775"/>
                        <a:ext cx="10888663" cy="39893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0" y="486137"/>
            <a:ext cx="152291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err="1"/>
              <a:t>Bloodmeal</a:t>
            </a:r>
            <a:r>
              <a:rPr lang="en-US" b="1" dirty="0"/>
              <a:t> titer (</a:t>
            </a:r>
            <a:r>
              <a:rPr lang="en-US" b="1" dirty="0" err="1"/>
              <a:t>pfu</a:t>
            </a:r>
            <a:r>
              <a:rPr lang="en-US" b="1" dirty="0"/>
              <a:t>/ml)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316120" y="578469"/>
            <a:ext cx="79111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6.2                                            4.5                                                 3.5</a:t>
            </a:r>
          </a:p>
        </p:txBody>
      </p:sp>
      <p:sp>
        <p:nvSpPr>
          <p:cNvPr id="5" name="Rectangle 4"/>
          <p:cNvSpPr/>
          <p:nvPr/>
        </p:nvSpPr>
        <p:spPr>
          <a:xfrm>
            <a:off x="6271690" y="1331089"/>
            <a:ext cx="1413900" cy="7523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5517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64A6CD2-168C-4ABF-8678-F9EE44262F55}"/>
              </a:ext>
            </a:extLst>
          </p:cNvPr>
          <p:cNvSpPr txBox="1"/>
          <p:nvPr/>
        </p:nvSpPr>
        <p:spPr>
          <a:xfrm>
            <a:off x="563837" y="5689381"/>
            <a:ext cx="11365781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Viral RNA detected in goat serum collected from jugular vein at 1, 2, 3 days post-vaccination (n=3 per virus). Graph shows RT-qPCR results of Log10 RVFV copy number detection, using L segment copy number standards.  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80A84873-6C13-490F-B9B5-975164664670}"/>
              </a:ext>
            </a:extLst>
          </p:cNvPr>
          <p:cNvSpPr/>
          <p:nvPr/>
        </p:nvSpPr>
        <p:spPr>
          <a:xfrm>
            <a:off x="3886982" y="565666"/>
            <a:ext cx="5008880" cy="51883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62275295"/>
              </p:ext>
            </p:extLst>
          </p:nvPr>
        </p:nvGraphicFramePr>
        <p:xfrm>
          <a:off x="2459062" y="880598"/>
          <a:ext cx="7171074" cy="42548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6336228" imgH="3759648" progId="Prism8.Document">
                  <p:embed/>
                </p:oleObj>
              </mc:Choice>
              <mc:Fallback>
                <p:oleObj name="Prism 8" r:id="rId2" imgW="6336228" imgH="375964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459062" y="880598"/>
                        <a:ext cx="7171074" cy="42548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6973906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561295" y="4818794"/>
            <a:ext cx="11069408" cy="12311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osquito cell lines were grown in T12.5 flasks and inoculated with RVFV MP12 at an MOI of 0.01.  Aliquots were removed at indicated intervals, stored in 20% FBS at -80C, then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titered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on Vero cells.  Data represent 3 biological replicates. Error bars depict standard error of the mean.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DDVax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mean peak titers were 6.15 and 7.12 log10 PFU/ml, in Aag2 and Ct, respectively. In contrast, MP-12 peak titers were 8.51 and 8.66 log10 PFU/ml, in Aag2 and Ct, respectively. Similarly, ZH501 peak titers were 6.93 and 7.95 log10 PFU/ml, in Aag2 and Ct, respectively. ATC-10 cells were not competent for virus infection.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6C86DF8D-D6F6-48C5-A5CA-789E50CC0AE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936177"/>
              </p:ext>
            </p:extLst>
          </p:nvPr>
        </p:nvGraphicFramePr>
        <p:xfrm>
          <a:off x="266921" y="1300767"/>
          <a:ext cx="11658157" cy="31682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9832065" imgH="2671263" progId="Prism8.Document">
                  <p:embed/>
                </p:oleObj>
              </mc:Choice>
              <mc:Fallback>
                <p:oleObj name="Prism 8" r:id="rId2" imgW="9832065" imgH="267126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66921" y="1300767"/>
                        <a:ext cx="11658157" cy="31682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5349516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156425373"/>
              </p:ext>
            </p:extLst>
          </p:nvPr>
        </p:nvGraphicFramePr>
        <p:xfrm>
          <a:off x="1893436" y="1799366"/>
          <a:ext cx="8144078" cy="2884170"/>
        </p:xfrm>
        <a:graphic>
          <a:graphicData uri="http://schemas.openxmlformats.org/drawingml/2006/table">
            <a:tbl>
              <a:tblPr bandRow="1">
                <a:tableStyleId>{073A0DAA-6AF3-43AB-8588-CEC1D06C72B9}</a:tableStyleId>
              </a:tblPr>
              <a:tblGrid>
                <a:gridCol w="1857578">
                  <a:extLst>
                    <a:ext uri="{9D8B030D-6E8A-4147-A177-3AD203B41FA5}">
                      <a16:colId xmlns:a16="http://schemas.microsoft.com/office/drawing/2014/main" val="1160933434"/>
                    </a:ext>
                  </a:extLst>
                </a:gridCol>
                <a:gridCol w="3848100">
                  <a:extLst>
                    <a:ext uri="{9D8B030D-6E8A-4147-A177-3AD203B41FA5}">
                      <a16:colId xmlns:a16="http://schemas.microsoft.com/office/drawing/2014/main" val="3357036597"/>
                    </a:ext>
                  </a:extLst>
                </a:gridCol>
                <a:gridCol w="2438400">
                  <a:extLst>
                    <a:ext uri="{9D8B030D-6E8A-4147-A177-3AD203B41FA5}">
                      <a16:colId xmlns:a16="http://schemas.microsoft.com/office/drawing/2014/main" val="2686735032"/>
                    </a:ext>
                  </a:extLst>
                </a:gridCol>
              </a:tblGrid>
              <a:tr h="167765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800" b="1" u="none" strike="noStrike" dirty="0">
                          <a:effectLst/>
                        </a:rPr>
                        <a:t>Table S1 Primers used in this study.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539916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Confirmation of MP-12 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56279899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Primer-segment-positio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Sequenc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Purpos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588076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VFL-3629_F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GGTGGATTGCAGCTTG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P-12 sequencin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3465072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VFL-3737_F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CTTAGCTGCAATAATTCAGC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</a:rPr>
                        <a:t> MP-12 sequencin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559542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VFL-3800_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AGCACTTGAGACTGCTGC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P-12 sequencin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6380474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VFL-5336_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ACTCAGGTCCCATGGGC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</a:rPr>
                        <a:t> MP-12 sequencin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7155803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VFM-703_F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CTGTGACCTTCTGAGTGC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P-12 sequencin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97908273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90538249"/>
                  </a:ext>
                </a:extLst>
              </a:tr>
              <a:tr h="1905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RVFV Copy number standards 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7503228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VFL-2173_T7_F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AATACGACTCACTATAGGGCAGGTGAGCCCTTCATTC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NA copy standards preparatio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99751293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VFL-3542_R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AGGGGTAAATGGCAAGGTAC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NA copy standards preparatio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40244446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VFL-2912fwdg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GAAAATTCCTGAGACACATG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robe-based RVFV detectio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78572740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VFL-2971revA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CTTCCTTGCATCATCTGAT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robe-based RVFV detectio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92346917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VFL-2950-Prob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(FAM)CAATGTAAGGGGCCTGTGTGGACTTGTG-(BHQ1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Probe-based RVFV detectio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0632159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108129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C96DD297-283F-4509-BB73-8C64025B9085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592012560"/>
              </p:ext>
            </p:extLst>
          </p:nvPr>
        </p:nvGraphicFramePr>
        <p:xfrm>
          <a:off x="838200" y="2366008"/>
          <a:ext cx="10548730" cy="2723949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2109746">
                  <a:extLst>
                    <a:ext uri="{9D8B030D-6E8A-4147-A177-3AD203B41FA5}">
                      <a16:colId xmlns:a16="http://schemas.microsoft.com/office/drawing/2014/main" val="3574656939"/>
                    </a:ext>
                  </a:extLst>
                </a:gridCol>
                <a:gridCol w="1619084">
                  <a:extLst>
                    <a:ext uri="{9D8B030D-6E8A-4147-A177-3AD203B41FA5}">
                      <a16:colId xmlns:a16="http://schemas.microsoft.com/office/drawing/2014/main" val="3653694424"/>
                    </a:ext>
                  </a:extLst>
                </a:gridCol>
                <a:gridCol w="2600408">
                  <a:extLst>
                    <a:ext uri="{9D8B030D-6E8A-4147-A177-3AD203B41FA5}">
                      <a16:colId xmlns:a16="http://schemas.microsoft.com/office/drawing/2014/main" val="238548011"/>
                    </a:ext>
                  </a:extLst>
                </a:gridCol>
                <a:gridCol w="2109746">
                  <a:extLst>
                    <a:ext uri="{9D8B030D-6E8A-4147-A177-3AD203B41FA5}">
                      <a16:colId xmlns:a16="http://schemas.microsoft.com/office/drawing/2014/main" val="848448310"/>
                    </a:ext>
                  </a:extLst>
                </a:gridCol>
                <a:gridCol w="2109746">
                  <a:extLst>
                    <a:ext uri="{9D8B030D-6E8A-4147-A177-3AD203B41FA5}">
                      <a16:colId xmlns:a16="http://schemas.microsoft.com/office/drawing/2014/main" val="3340285258"/>
                    </a:ext>
                  </a:extLst>
                </a:gridCol>
              </a:tblGrid>
              <a:tr h="275955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bg1"/>
                          </a:solidFill>
                        </a:rPr>
                        <a:t>Speci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bg1"/>
                          </a:solidFill>
                        </a:rPr>
                        <a:t>Stra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bg1"/>
                          </a:solidFill>
                        </a:rPr>
                        <a:t>Bodi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bg1"/>
                          </a:solidFill>
                        </a:rPr>
                        <a:t>Legs/wing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bg1"/>
                          </a:solidFill>
                        </a:rPr>
                        <a:t>Saliv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62082416"/>
                  </a:ext>
                </a:extLst>
              </a:tr>
              <a:tr h="285750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/>
                        <a:t>Aedes aegypti</a:t>
                      </a:r>
                      <a:endParaRPr lang="en-US" sz="1600" b="1" i="1" dirty="0"/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ZH501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     113/113 (100.0%)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/>
                        <a:t>86/113 (76.1%)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64/113 (56.6%)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val="1409178624"/>
                  </a:ext>
                </a:extLst>
              </a:tr>
              <a:tr h="334736">
                <a:tc>
                  <a:txBody>
                    <a:bodyPr/>
                    <a:lstStyle/>
                    <a:p>
                      <a:pPr algn="ctr"/>
                      <a:endParaRPr lang="en-US" sz="1600" b="1" i="1" dirty="0"/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MP12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74/120 (61.7%)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42/120 (32.5%)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30/120 (25.0%)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val="904248469"/>
                  </a:ext>
                </a:extLst>
              </a:tr>
              <a:tr h="293914">
                <a:tc>
                  <a:txBody>
                    <a:bodyPr/>
                    <a:lstStyle/>
                    <a:p>
                      <a:pPr algn="ctr"/>
                      <a:endParaRPr lang="en-US" sz="1600" b="1" i="1" dirty="0"/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 err="1">
                          <a:solidFill>
                            <a:schemeClr val="tx1"/>
                          </a:solidFill>
                        </a:rPr>
                        <a:t>DDVax</a:t>
                      </a:r>
                      <a:endParaRPr lang="en-US" sz="1600" b="0" dirty="0">
                        <a:solidFill>
                          <a:schemeClr val="tx1"/>
                        </a:solidFill>
                      </a:endParaRP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113/120 (94.2%)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25/120 (20.8%)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11/120(9.2%)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val="332198697"/>
                  </a:ext>
                </a:extLst>
              </a:tr>
              <a:tr h="253093">
                <a:tc>
                  <a:txBody>
                    <a:bodyPr/>
                    <a:lstStyle/>
                    <a:p>
                      <a:pPr algn="ctr"/>
                      <a:endParaRPr lang="en-US" sz="1600" b="1" i="1" dirty="0"/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endParaRPr lang="en-US" sz="1600" b="0">
                        <a:solidFill>
                          <a:schemeClr val="tx1"/>
                        </a:solidFill>
                      </a:endParaRP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endParaRPr lang="en-US" sz="1600" b="0" dirty="0">
                        <a:solidFill>
                          <a:schemeClr val="tx1"/>
                        </a:solidFill>
                      </a:endParaRP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endParaRPr lang="en-US" sz="1600" b="0" dirty="0">
                        <a:solidFill>
                          <a:schemeClr val="tx1"/>
                        </a:solidFill>
                      </a:endParaRP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endParaRPr lang="en-US" sz="1600" b="0" dirty="0">
                        <a:solidFill>
                          <a:schemeClr val="tx1"/>
                        </a:solidFill>
                      </a:endParaRP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val="2807944008"/>
                  </a:ext>
                </a:extLst>
              </a:tr>
              <a:tr h="321673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/>
                        <a:t>Culex </a:t>
                      </a:r>
                      <a:r>
                        <a:rPr lang="en-US" sz="1600" b="1" dirty="0" err="1"/>
                        <a:t>tarsalis</a:t>
                      </a:r>
                      <a:endParaRPr lang="en-US" sz="1600" b="1" i="1" dirty="0"/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ZH501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111/120 (92.5%)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100/120 (83.3%)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98/120 (81.7%)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val="83453183"/>
                  </a:ext>
                </a:extLst>
              </a:tr>
              <a:tr h="342900">
                <a:tc>
                  <a:txBody>
                    <a:bodyPr/>
                    <a:lstStyle/>
                    <a:p>
                      <a:pPr algn="ctr"/>
                      <a:endParaRPr lang="en-US" sz="1600" b="1" dirty="0"/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MP12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120/120 (100.0%)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120/120 (100.0%)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113/120 (94.2%)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val="4107225880"/>
                  </a:ext>
                </a:extLst>
              </a:tr>
              <a:tr h="428694">
                <a:tc>
                  <a:txBody>
                    <a:bodyPr/>
                    <a:lstStyle/>
                    <a:p>
                      <a:pPr algn="ctr"/>
                      <a:endParaRPr lang="en-US" sz="1600" b="1" dirty="0"/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 err="1">
                          <a:solidFill>
                            <a:schemeClr val="tx1"/>
                          </a:solidFill>
                        </a:rPr>
                        <a:t>DDVax</a:t>
                      </a:r>
                      <a:endParaRPr lang="en-US" sz="1600" b="0" dirty="0">
                        <a:solidFill>
                          <a:schemeClr val="tx1"/>
                        </a:solidFill>
                      </a:endParaRP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111/120 (92.5%)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94/120 (78.3%)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104/120 (86.7%)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val="780446573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ABA401D8-EB47-4DFB-9CE2-1A900DC5E756}"/>
              </a:ext>
            </a:extLst>
          </p:cNvPr>
          <p:cNvSpPr txBox="1"/>
          <p:nvPr/>
        </p:nvSpPr>
        <p:spPr>
          <a:xfrm>
            <a:off x="838200" y="5303375"/>
            <a:ext cx="88419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able S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 RNA positive RVFV-exposed samples from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in vitro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osquito challenge.</a:t>
            </a:r>
          </a:p>
        </p:txBody>
      </p:sp>
    </p:spTree>
    <p:extLst>
      <p:ext uri="{BB962C8B-B14F-4D97-AF65-F5344CB8AC3E}">
        <p14:creationId xmlns:p14="http://schemas.microsoft.com/office/powerpoint/2010/main" val="7342369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C96DD297-283F-4509-BB73-8C64025B9085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021046822"/>
              </p:ext>
            </p:extLst>
          </p:nvPr>
        </p:nvGraphicFramePr>
        <p:xfrm>
          <a:off x="821635" y="2425516"/>
          <a:ext cx="10548730" cy="1926162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2109746">
                  <a:extLst>
                    <a:ext uri="{9D8B030D-6E8A-4147-A177-3AD203B41FA5}">
                      <a16:colId xmlns:a16="http://schemas.microsoft.com/office/drawing/2014/main" val="3574656939"/>
                    </a:ext>
                  </a:extLst>
                </a:gridCol>
                <a:gridCol w="1619084">
                  <a:extLst>
                    <a:ext uri="{9D8B030D-6E8A-4147-A177-3AD203B41FA5}">
                      <a16:colId xmlns:a16="http://schemas.microsoft.com/office/drawing/2014/main" val="3653694424"/>
                    </a:ext>
                  </a:extLst>
                </a:gridCol>
                <a:gridCol w="2600408">
                  <a:extLst>
                    <a:ext uri="{9D8B030D-6E8A-4147-A177-3AD203B41FA5}">
                      <a16:colId xmlns:a16="http://schemas.microsoft.com/office/drawing/2014/main" val="238548011"/>
                    </a:ext>
                  </a:extLst>
                </a:gridCol>
                <a:gridCol w="2109746">
                  <a:extLst>
                    <a:ext uri="{9D8B030D-6E8A-4147-A177-3AD203B41FA5}">
                      <a16:colId xmlns:a16="http://schemas.microsoft.com/office/drawing/2014/main" val="848448310"/>
                    </a:ext>
                  </a:extLst>
                </a:gridCol>
                <a:gridCol w="2109746">
                  <a:extLst>
                    <a:ext uri="{9D8B030D-6E8A-4147-A177-3AD203B41FA5}">
                      <a16:colId xmlns:a16="http://schemas.microsoft.com/office/drawing/2014/main" val="3340285258"/>
                    </a:ext>
                  </a:extLst>
                </a:gridCol>
              </a:tblGrid>
              <a:tr h="428694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Speci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err="1"/>
                        <a:t>DDVax</a:t>
                      </a:r>
                      <a:r>
                        <a:rPr lang="en-US" dirty="0"/>
                        <a:t> titer, log10 PFU/m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Bodi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Legs/wing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Saliv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62082416"/>
                  </a:ext>
                </a:extLst>
              </a:tr>
              <a:tr h="428694">
                <a:tc>
                  <a:txBody>
                    <a:bodyPr/>
                    <a:lstStyle/>
                    <a:p>
                      <a:pPr algn="ctr"/>
                      <a:r>
                        <a:rPr lang="en-US" b="1" dirty="0" err="1"/>
                        <a:t>Culex</a:t>
                      </a:r>
                      <a:r>
                        <a:rPr lang="en-US" b="1" dirty="0"/>
                        <a:t> </a:t>
                      </a:r>
                      <a:r>
                        <a:rPr lang="en-US" b="1" dirty="0" err="1"/>
                        <a:t>tarsalis</a:t>
                      </a:r>
                      <a:endParaRPr lang="en-US" b="1" i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>
                          <a:solidFill>
                            <a:schemeClr val="tx1"/>
                          </a:solidFill>
                        </a:rPr>
                        <a:t>6.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>
                          <a:solidFill>
                            <a:schemeClr val="tx1"/>
                          </a:solidFill>
                        </a:rPr>
                        <a:t>     87/90 (96.7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58/90 (64.4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>
                          <a:solidFill>
                            <a:schemeClr val="tx1"/>
                          </a:solidFill>
                        </a:rPr>
                        <a:t>18/90 (20.0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09178624"/>
                  </a:ext>
                </a:extLst>
              </a:tr>
              <a:tr h="428694">
                <a:tc>
                  <a:txBody>
                    <a:bodyPr/>
                    <a:lstStyle/>
                    <a:p>
                      <a:pPr algn="ctr"/>
                      <a:endParaRPr lang="en-US" b="1" i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>
                          <a:solidFill>
                            <a:schemeClr val="tx1"/>
                          </a:solidFill>
                        </a:rPr>
                        <a:t>4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>
                          <a:solidFill>
                            <a:schemeClr val="tx1"/>
                          </a:solidFill>
                        </a:rPr>
                        <a:t>45/90 (50.0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44/90 (48.9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>
                          <a:solidFill>
                            <a:schemeClr val="tx1"/>
                          </a:solidFill>
                        </a:rPr>
                        <a:t>23/90 (25.6%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904248469"/>
                  </a:ext>
                </a:extLst>
              </a:tr>
              <a:tr h="428694">
                <a:tc>
                  <a:txBody>
                    <a:bodyPr/>
                    <a:lstStyle/>
                    <a:p>
                      <a:pPr algn="ctr"/>
                      <a:endParaRPr lang="en-US" b="1" i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>
                          <a:solidFill>
                            <a:schemeClr val="tx1"/>
                          </a:solidFill>
                        </a:rPr>
                        <a:t>3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>
                          <a:solidFill>
                            <a:schemeClr val="tx1"/>
                          </a:solidFill>
                        </a:rPr>
                        <a:t>45/90 (50.0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7/90 (18.9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>
                          <a:solidFill>
                            <a:schemeClr val="tx1"/>
                          </a:solidFill>
                        </a:rPr>
                        <a:t>17/90(18.9%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32198697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EB3C0922-ABA4-4B59-A82E-8B58573E437D}"/>
              </a:ext>
            </a:extLst>
          </p:cNvPr>
          <p:cNvSpPr txBox="1"/>
          <p:nvPr/>
        </p:nvSpPr>
        <p:spPr>
          <a:xfrm>
            <a:off x="821634" y="4527495"/>
            <a:ext cx="101727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able S3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NA positive RVFV-exposed samples after 14 dpi from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in vitro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osquito challenge using serial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DDVax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dilutions.</a:t>
            </a:r>
          </a:p>
        </p:txBody>
      </p:sp>
    </p:spTree>
    <p:extLst>
      <p:ext uri="{BB962C8B-B14F-4D97-AF65-F5344CB8AC3E}">
        <p14:creationId xmlns:p14="http://schemas.microsoft.com/office/powerpoint/2010/main" val="1373903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41</TotalTime>
  <Words>548</Words>
  <Application>Microsoft Office PowerPoint</Application>
  <PresentationFormat>Widescreen</PresentationFormat>
  <Paragraphs>100</Paragraphs>
  <Slides>7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senberg,Corey</dc:creator>
  <cp:lastModifiedBy>Corey</cp:lastModifiedBy>
  <cp:revision>449</cp:revision>
  <cp:lastPrinted>2019-11-08T17:14:39Z</cp:lastPrinted>
  <dcterms:created xsi:type="dcterms:W3CDTF">2019-11-08T17:11:46Z</dcterms:created>
  <dcterms:modified xsi:type="dcterms:W3CDTF">2021-11-17T17:15:38Z</dcterms:modified>
</cp:coreProperties>
</file>